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jpeg" ContentType="image/jpe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9947275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48BE55-06CC-4E18-A976-15BB89B174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999FB4-7F9F-477F-842E-27193E3213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D57AC4-9180-4C72-9834-4E7238B658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D4D500-9CBF-4589-87F8-24A5F4C7C4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9A3AA2-DA14-42D8-955F-C228870E3A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2BE840-EFBC-41CC-9A76-4DA359D067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FAED2C-07FA-4B67-9F0C-006B319E54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472BA6-85D0-4796-AC6D-9D6506E1B2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010D40-1FCF-4B77-BD25-4A0C9F7345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D71368-DBD3-4C12-A360-435506050D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B2280D-5580-4541-A068-C728769D67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0A5BD0-47A7-4075-8AA0-3F22BDFC84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0123A1-0A0C-4EC1-B059-A2E1E7235324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4.png"/><Relationship Id="rId6" Type="http://schemas.openxmlformats.org/officeDocument/2006/relationships/image" Target="../media/image4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1026360" y="13906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TextBox 31"/>
          <p:cNvSpPr/>
          <p:nvPr/>
        </p:nvSpPr>
        <p:spPr>
          <a:xfrm>
            <a:off x="1026360" y="33591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3" name="组合 2"/>
          <p:cNvGrpSpPr/>
          <p:nvPr/>
        </p:nvGrpSpPr>
        <p:grpSpPr>
          <a:xfrm>
            <a:off x="1749960" y="1203480"/>
            <a:ext cx="2690640" cy="1736640"/>
            <a:chOff x="1749960" y="1203480"/>
            <a:chExt cx="2690640" cy="1736640"/>
          </a:xfrm>
        </p:grpSpPr>
        <p:grpSp>
          <p:nvGrpSpPr>
            <p:cNvPr id="44" name="组合 30"/>
            <p:cNvGrpSpPr/>
            <p:nvPr/>
          </p:nvGrpSpPr>
          <p:grpSpPr>
            <a:xfrm>
              <a:off x="2048040" y="1203480"/>
              <a:ext cx="2392560" cy="1736640"/>
              <a:chOff x="2048040" y="1203480"/>
              <a:chExt cx="2392560" cy="1736640"/>
            </a:xfrm>
          </p:grpSpPr>
          <p:pic>
            <p:nvPicPr>
              <p:cNvPr id="45" name="Picture 3" descr="G:\博士后\2016\2016-03-11-A2780 PCBP1 KD-siPCBP2-GAPDH-52.jpg"/>
              <p:cNvPicPr/>
              <p:nvPr/>
            </p:nvPicPr>
            <p:blipFill>
              <a:blip r:embed="rId1"/>
              <a:srcRect l="50860" t="65109" r="39194" b="31214"/>
              <a:stretch/>
            </p:blipFill>
            <p:spPr>
              <a:xfrm>
                <a:off x="2048040" y="2651760"/>
                <a:ext cx="1720800" cy="288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Picture 4" descr="G:\博士后\2016\2016-03-11-A2780 PCBP1 KD-siPCBP2-GAPDH-52.jpg"/>
              <p:cNvPicPr/>
              <p:nvPr/>
            </p:nvPicPr>
            <p:blipFill>
              <a:blip r:embed="rId2"/>
              <a:srcRect l="56099" t="40954" r="19606" b="39407"/>
              <a:stretch/>
            </p:blipFill>
            <p:spPr>
              <a:xfrm>
                <a:off x="2052000" y="2041200"/>
                <a:ext cx="1719000" cy="288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7" name="TextBox 21"/>
              <p:cNvSpPr/>
              <p:nvPr/>
            </p:nvSpPr>
            <p:spPr>
              <a:xfrm rot="17701800">
                <a:off x="2164680" y="1636920"/>
                <a:ext cx="64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" name="TextBox 22"/>
              <p:cNvSpPr/>
              <p:nvPr/>
            </p:nvSpPr>
            <p:spPr>
              <a:xfrm rot="17701800">
                <a:off x="2607840" y="1527840"/>
                <a:ext cx="88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iPCBP2-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" name="TextBox 23"/>
              <p:cNvSpPr/>
              <p:nvPr/>
            </p:nvSpPr>
            <p:spPr>
              <a:xfrm rot="17701800">
                <a:off x="3106440" y="1523880"/>
                <a:ext cx="88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iPCBP2-2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" name="TextBox 26"/>
              <p:cNvSpPr/>
              <p:nvPr/>
            </p:nvSpPr>
            <p:spPr>
              <a:xfrm>
                <a:off x="3727440" y="2074320"/>
                <a:ext cx="654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CBP2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" name="TextBox 27"/>
              <p:cNvSpPr/>
              <p:nvPr/>
            </p:nvSpPr>
            <p:spPr>
              <a:xfrm>
                <a:off x="3720240" y="234864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27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TextBox 28"/>
              <p:cNvSpPr/>
              <p:nvPr/>
            </p:nvSpPr>
            <p:spPr>
              <a:xfrm>
                <a:off x="3709800" y="2651760"/>
                <a:ext cx="730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APDH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pic>
            <p:nvPicPr>
              <p:cNvPr id="53" name="Picture 2" descr="G:\博士后\2016\20160314 siPCBP2-p27.jpg"/>
              <p:cNvPicPr/>
              <p:nvPr/>
            </p:nvPicPr>
            <p:blipFill>
              <a:blip r:embed="rId3">
                <a:lum bright="4000"/>
              </a:blip>
              <a:srcRect l="8848" t="21722" r="20079" b="69784"/>
              <a:stretch/>
            </p:blipFill>
            <p:spPr>
              <a:xfrm>
                <a:off x="2048040" y="2368440"/>
                <a:ext cx="1720800" cy="24696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54" name="TextBox 99"/>
            <p:cNvSpPr/>
            <p:nvPr/>
          </p:nvSpPr>
          <p:spPr>
            <a:xfrm>
              <a:off x="1749960" y="2419200"/>
              <a:ext cx="404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47 -­ 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TextBox 100"/>
            <p:cNvSpPr/>
            <p:nvPr/>
          </p:nvSpPr>
          <p:spPr>
            <a:xfrm>
              <a:off x="1749960" y="2732040"/>
              <a:ext cx="404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452 ­- 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TextBox 101"/>
            <p:cNvSpPr/>
            <p:nvPr/>
          </p:nvSpPr>
          <p:spPr>
            <a:xfrm>
              <a:off x="1790280" y="1859040"/>
              <a:ext cx="287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bp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TextBox 99"/>
            <p:cNvSpPr/>
            <p:nvPr/>
          </p:nvSpPr>
          <p:spPr>
            <a:xfrm>
              <a:off x="1756440" y="2114280"/>
              <a:ext cx="404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53 -­ 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58" name="组合 3"/>
          <p:cNvGrpSpPr/>
          <p:nvPr/>
        </p:nvGrpSpPr>
        <p:grpSpPr>
          <a:xfrm>
            <a:off x="1531800" y="3191040"/>
            <a:ext cx="4076280" cy="2388960"/>
            <a:chOff x="1531800" y="3191040"/>
            <a:chExt cx="4076280" cy="2388960"/>
          </a:xfrm>
        </p:grpSpPr>
        <p:grpSp>
          <p:nvGrpSpPr>
            <p:cNvPr id="59" name="组合 3"/>
            <p:cNvGrpSpPr/>
            <p:nvPr/>
          </p:nvGrpSpPr>
          <p:grpSpPr>
            <a:xfrm>
              <a:off x="1810440" y="3191040"/>
              <a:ext cx="3797640" cy="2388960"/>
              <a:chOff x="1810440" y="3191040"/>
              <a:chExt cx="3797640" cy="2388960"/>
            </a:xfrm>
          </p:grpSpPr>
          <p:pic>
            <p:nvPicPr>
              <p:cNvPr id="60" name="Picture 2" descr="G:\博士后\20160313-A2780 cell siPCBP2 for p27.tif"/>
              <p:cNvPicPr/>
              <p:nvPr/>
            </p:nvPicPr>
            <p:blipFill>
              <a:blip r:embed="rId4"/>
              <a:srcRect l="10205" t="10123" r="73183" b="86900"/>
              <a:stretch/>
            </p:blipFill>
            <p:spPr>
              <a:xfrm>
                <a:off x="1810440" y="4217040"/>
                <a:ext cx="2824920" cy="419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1" name="Picture 2" descr="G:\博士后\20160313-A2780 cell siPCBP2 for p27.tif"/>
              <p:cNvPicPr/>
              <p:nvPr/>
            </p:nvPicPr>
            <p:blipFill>
              <a:blip r:embed="rId5"/>
              <a:srcRect l="10205" t="14783" r="73183" b="81931"/>
              <a:stretch/>
            </p:blipFill>
            <p:spPr>
              <a:xfrm>
                <a:off x="1810440" y="4684680"/>
                <a:ext cx="2824920" cy="419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2" name="Picture 2" descr="G:\博士后\20160313-A2780 cell siPCBP2 for p27.tif"/>
              <p:cNvPicPr/>
              <p:nvPr/>
            </p:nvPicPr>
            <p:blipFill>
              <a:blip r:embed="rId6"/>
              <a:srcRect l="8504" t="64296" r="74884" b="32669"/>
              <a:stretch/>
            </p:blipFill>
            <p:spPr>
              <a:xfrm>
                <a:off x="1810440" y="5151600"/>
                <a:ext cx="2824920" cy="428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3" name="TextBox 7"/>
              <p:cNvSpPr/>
              <p:nvPr/>
            </p:nvSpPr>
            <p:spPr>
              <a:xfrm>
                <a:off x="4598280" y="4327200"/>
                <a:ext cx="1009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FP-PCBP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4" name="TextBox 8"/>
              <p:cNvSpPr/>
              <p:nvPr/>
            </p:nvSpPr>
            <p:spPr>
              <a:xfrm>
                <a:off x="4602240" y="473256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27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5" name="TextBox 9"/>
              <p:cNvSpPr/>
              <p:nvPr/>
            </p:nvSpPr>
            <p:spPr>
              <a:xfrm>
                <a:off x="4582440" y="5257440"/>
                <a:ext cx="730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APDH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6" name="TextBox 10"/>
              <p:cNvSpPr/>
              <p:nvPr/>
            </p:nvSpPr>
            <p:spPr>
              <a:xfrm rot="17701800">
                <a:off x="1875600" y="3830040"/>
                <a:ext cx="64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7" name="TextBox 11"/>
              <p:cNvSpPr/>
              <p:nvPr/>
            </p:nvSpPr>
            <p:spPr>
              <a:xfrm rot="17701800">
                <a:off x="2240280" y="3705840"/>
                <a:ext cx="88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iPCBP2-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8" name="TextBox 12"/>
              <p:cNvSpPr/>
              <p:nvPr/>
            </p:nvSpPr>
            <p:spPr>
              <a:xfrm rot="17701800">
                <a:off x="2672280" y="3705840"/>
                <a:ext cx="88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iPCBP2-2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9" name="TextBox 13"/>
              <p:cNvSpPr/>
              <p:nvPr/>
            </p:nvSpPr>
            <p:spPr>
              <a:xfrm rot="17701800">
                <a:off x="3171960" y="3830040"/>
                <a:ext cx="64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0" name="TextBox 14"/>
              <p:cNvSpPr/>
              <p:nvPr/>
            </p:nvSpPr>
            <p:spPr>
              <a:xfrm rot="17701800">
                <a:off x="3536640" y="3705840"/>
                <a:ext cx="88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iPCBP2-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1" name="TextBox 15"/>
              <p:cNvSpPr/>
              <p:nvPr/>
            </p:nvSpPr>
            <p:spPr>
              <a:xfrm rot="17701800">
                <a:off x="3968640" y="3705840"/>
                <a:ext cx="88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iPCBP2-2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2" name="直接连接符 16"/>
              <p:cNvSpPr/>
              <p:nvPr/>
            </p:nvSpPr>
            <p:spPr>
              <a:xfrm>
                <a:off x="2036520" y="3422520"/>
                <a:ext cx="1284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3" name="TextBox 17"/>
              <p:cNvSpPr/>
              <p:nvPr/>
            </p:nvSpPr>
            <p:spPr>
              <a:xfrm>
                <a:off x="2540880" y="3200400"/>
                <a:ext cx="485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FP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4" name="直接连接符 18"/>
              <p:cNvSpPr/>
              <p:nvPr/>
            </p:nvSpPr>
            <p:spPr>
              <a:xfrm>
                <a:off x="3394080" y="3422520"/>
                <a:ext cx="1282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5" name="TextBox 19"/>
              <p:cNvSpPr/>
              <p:nvPr/>
            </p:nvSpPr>
            <p:spPr>
              <a:xfrm>
                <a:off x="3702240" y="3191040"/>
                <a:ext cx="654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CBP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76" name="TextBox 119"/>
            <p:cNvSpPr/>
            <p:nvPr/>
          </p:nvSpPr>
          <p:spPr>
            <a:xfrm>
              <a:off x="1544400" y="4355640"/>
              <a:ext cx="356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65 -­ 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TextBox 120"/>
            <p:cNvSpPr/>
            <p:nvPr/>
          </p:nvSpPr>
          <p:spPr>
            <a:xfrm>
              <a:off x="1544400" y="4854600"/>
              <a:ext cx="356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7 -­ 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TextBox 121"/>
            <p:cNvSpPr/>
            <p:nvPr/>
          </p:nvSpPr>
          <p:spPr>
            <a:xfrm>
              <a:off x="1544400" y="5294880"/>
              <a:ext cx="356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37­ - 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TextBox 122"/>
            <p:cNvSpPr/>
            <p:nvPr/>
          </p:nvSpPr>
          <p:spPr>
            <a:xfrm>
              <a:off x="1531800" y="4011120"/>
              <a:ext cx="34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0" name="Rectangle 42"/>
          <p:cNvSpPr/>
          <p:nvPr/>
        </p:nvSpPr>
        <p:spPr>
          <a:xfrm>
            <a:off x="189000" y="5734080"/>
            <a:ext cx="64008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6.No effect of PCBP2 on p27 expression on both mRNA and protein level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A). RT-PCR analysis of PCBP2 knockdown efficiency by 2 specific siRNAs in A2780 GFP control cells or GFP-PCBP1 overexpressing cell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B). Immunoblot analysis of p27 expression upon PCBP2 knockdown in A2780 GFP control cells or GFP-PCBP1 overexpressing cells. GAPDH was used as a loading control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9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dministrator</dc:creator>
  <dc:description/>
  <dc:language>en-US</dc:language>
  <cp:lastModifiedBy>Hongshun</cp:lastModifiedBy>
  <dcterms:modified xsi:type="dcterms:W3CDTF">2018-06-25T03:15:24Z</dcterms:modified>
  <cp:revision>185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